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56" d="100"/>
          <a:sy n="56" d="100"/>
        </p:scale>
        <p:origin x="100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36A747C-41D7-59B8-D2BC-9BA7A789354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703A9857-8129-F641-5350-281AB94AFA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7D38757-A044-86DD-8C0D-908F05DE21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D9B35-75EF-48BB-9E97-61DECC557738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31AACDE-289A-F385-AA9C-926BCCD5E9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0CD6771-6A64-5737-526A-8E863A4F37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9B921-A395-46A3-BA03-0C9EB3D8B1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469970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2B25706-520E-B009-6501-7363EAB17D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8D887410-BEF9-2BA4-BA6F-42BE686F26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73EA9E8-2AA1-AE9A-B51D-3DC2833472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D9B35-75EF-48BB-9E97-61DECC557738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AC8EC60-2C87-21B0-8DAA-FF26D2A882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984B6FE-F060-E403-7AE3-488AAAC466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9B921-A395-46A3-BA03-0C9EB3D8B1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798229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D68D4C0F-FB35-CA9D-B5EA-78B8522D49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0DB0B625-596D-278F-25F9-A5F3F37454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9A75653-9E7C-478E-C6CD-A7FF28891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D9B35-75EF-48BB-9E97-61DECC557738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D275A99-95D0-3987-B489-65217E065C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847DEA7-413E-3909-E368-20CE0EE92E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9B921-A395-46A3-BA03-0C9EB3D8B1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30634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4F078ED-0D7A-6006-805C-5A4DBC5A0B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036B232-30E1-A604-4113-A3BB6003498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D610F37-FA80-B582-3BBD-862D7E85B9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D9B35-75EF-48BB-9E97-61DECC557738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F5FBAC4-2A4D-1E89-6105-80BDBD9223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D92DFCA-7B0D-D688-5A1A-8886D75EC9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9B921-A395-46A3-BA03-0C9EB3D8B1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233255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102B57E-E6C6-DDDC-CAF2-1BE738B768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67465E3-B17C-F0BD-E170-BF1AA8C0B2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7726C4E-57C1-F40A-95A1-59B88525ED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D9B35-75EF-48BB-9E97-61DECC557738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57769A5-B8FE-009C-D14B-2C3FD50A29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D10593C-DB87-262F-B33B-E1165D0351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9B921-A395-46A3-BA03-0C9EB3D8B1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826041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8DDEF77-A44C-6CDD-1304-0FB2738D4A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F2DA108-EABA-51E6-E824-C8A30335EEF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51943CCA-A9A6-B7AE-49BF-328986BE5A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B18DA80-9D84-E5CD-1CD4-025F53894C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D9B35-75EF-48BB-9E97-61DECC557738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39E9C7B-4333-A9F2-CEDB-398E1464DE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D4F62BC-C68B-BF48-4FFB-E9021762B3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9B921-A395-46A3-BA03-0C9EB3D8B1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994060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A25BFB7-CE39-49B2-BE79-6418D35EE8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10EEEBB-E7ED-E4CA-1768-A6AAE891BD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95730AF6-B413-D6E9-A39D-858C37F8E5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3AA2AFFD-A3F4-AB37-0034-5949C3DFDB0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BDB37121-5C6E-79E6-1FE9-A5AD4CB918C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F748811B-2BE7-EBCE-656B-D88520CC09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D9B35-75EF-48BB-9E97-61DECC557738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7CE78D49-098F-9E68-45A4-DB0125D5CD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4A1F7387-3480-9A69-1FC6-9B8D1A32A0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9B921-A395-46A3-BA03-0C9EB3D8B1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535270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92B7C78-EDA3-1503-9298-424A3D382B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B7EB366B-DBEA-17FB-C10B-B5AE23122F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D9B35-75EF-48BB-9E97-61DECC557738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57D02003-F7F5-7F20-2C19-AEA731FDB1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DBA1D784-648D-FD3A-72BC-2D5D8F43C1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9B921-A395-46A3-BA03-0C9EB3D8B1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1465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E129AE4D-A303-C275-E567-B883DEB3BA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D9B35-75EF-48BB-9E97-61DECC557738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0107E0C9-6E35-96B6-2895-8FF3568FFF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CECA06AA-84B8-30F0-6D92-9B09D90C0D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9B921-A395-46A3-BA03-0C9EB3D8B1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6552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5BA43B5-EEE5-7D13-4F2B-C1CE7EA010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F51A1C0-DD32-BD6B-FC07-CEAF795831A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95FA3B3-97B3-990E-A2CF-4CD66AFCDB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3FC5FD6-9F76-CE13-ACE9-46AA47D593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D9B35-75EF-48BB-9E97-61DECC557738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D274120-86FA-C035-2D25-1D47A8A3A0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DDB4039-42C3-0E25-B44F-B8F22A77FF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9B921-A395-46A3-BA03-0C9EB3D8B1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89857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7A84ADB-42BB-9B8A-8D56-787A508929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F9B95A21-4A21-1BD6-DA18-42D0D40DFC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19B7BBF-6180-F1CA-19E3-6A5EED2F6F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D547508-9EAE-356A-FAB2-47C35DA39C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D9B35-75EF-48BB-9E97-61DECC557738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48A47BA-D79B-FF35-ED67-239BE7707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4D429BF-7F00-9E82-98A2-1C6A0D430F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9B921-A395-46A3-BA03-0C9EB3D8B1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5509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353C2724-8234-BBDA-1E6B-2B7370F2BB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5BB1D40-9048-AF34-1D5D-3510CBED70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5411A2A-ABB4-A502-B483-34E3075E3D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2D9B35-75EF-48BB-9E97-61DECC557738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F45073C-2529-CA45-354F-7DECFDDD0E4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68365CF-6AE6-FDC1-0AE3-B670BEFAD5F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79B921-A395-46A3-BA03-0C9EB3D8B1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990463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EFBE3D9-55E1-33CC-7F0A-E4B58D81468C}"/>
              </a:ext>
            </a:extLst>
          </p:cNvPr>
          <p:cNvSpPr txBox="1"/>
          <p:nvPr/>
        </p:nvSpPr>
        <p:spPr>
          <a:xfrm>
            <a:off x="560070" y="201344"/>
            <a:ext cx="111556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dirty="0"/>
              <a:t>Supplementary Figure 1: Overall Survival curves. A, INT cohort; B, STRASS cohort; C, INT cohort according to CINSARC; D, STRASS according to CINSARC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824F09F-8FA8-184D-15B4-3AF24F2819AA}"/>
              </a:ext>
            </a:extLst>
          </p:cNvPr>
          <p:cNvSpPr txBox="1"/>
          <p:nvPr/>
        </p:nvSpPr>
        <p:spPr>
          <a:xfrm>
            <a:off x="2400299" y="103163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A3CBA02-8905-61F5-ADB7-8E20AA96EC43}"/>
              </a:ext>
            </a:extLst>
          </p:cNvPr>
          <p:cNvSpPr txBox="1"/>
          <p:nvPr/>
        </p:nvSpPr>
        <p:spPr>
          <a:xfrm>
            <a:off x="6274777" y="1031631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dirty="0"/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A308E85-5AFB-F927-C97D-3D2CE48272F8}"/>
              </a:ext>
            </a:extLst>
          </p:cNvPr>
          <p:cNvSpPr txBox="1"/>
          <p:nvPr/>
        </p:nvSpPr>
        <p:spPr>
          <a:xfrm>
            <a:off x="2400299" y="342900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dirty="0"/>
              <a:t>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A020D98-C80C-E7CC-7401-EA0D431575FB}"/>
              </a:ext>
            </a:extLst>
          </p:cNvPr>
          <p:cNvSpPr txBox="1"/>
          <p:nvPr/>
        </p:nvSpPr>
        <p:spPr>
          <a:xfrm>
            <a:off x="6274777" y="342900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dirty="0"/>
              <a:t>D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E6EA69A4-A674-3B31-9F4E-8B2A9829CCB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6499" y="1216297"/>
            <a:ext cx="2539993" cy="2539993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531D568-AE94-FD26-F5E4-510606E2226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36471" y="1031631"/>
            <a:ext cx="2724659" cy="272465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61B68E5C-3284-EBA2-DA93-B4BB49F341B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6498" y="3876674"/>
            <a:ext cx="2539993" cy="2591438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2ABF1AFA-B70A-0D39-3BAC-DFDC23B5D8D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36471" y="3876674"/>
            <a:ext cx="2576060" cy="26999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489032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asquali Sandro</dc:creator>
  <cp:lastModifiedBy>Pasquali Sandro</cp:lastModifiedBy>
  <cp:revision>1</cp:revision>
  <dcterms:created xsi:type="dcterms:W3CDTF">2025-05-21T11:07:36Z</dcterms:created>
  <dcterms:modified xsi:type="dcterms:W3CDTF">2025-05-21T11:08:13Z</dcterms:modified>
</cp:coreProperties>
</file>